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94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43A551-39C6-4F69-B9C2-D1EB4B4182AB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84838-852D-4DD5-BE68-2604436C78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25371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43A551-39C6-4F69-B9C2-D1EB4B4182AB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84838-852D-4DD5-BE68-2604436C78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89544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43A551-39C6-4F69-B9C2-D1EB4B4182AB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84838-852D-4DD5-BE68-2604436C78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34990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43A551-39C6-4F69-B9C2-D1EB4B4182AB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84838-852D-4DD5-BE68-2604436C78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2968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43A551-39C6-4F69-B9C2-D1EB4B4182AB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84838-852D-4DD5-BE68-2604436C78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96036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43A551-39C6-4F69-B9C2-D1EB4B4182AB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84838-852D-4DD5-BE68-2604436C78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24307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43A551-39C6-4F69-B9C2-D1EB4B4182AB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84838-852D-4DD5-BE68-2604436C78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38224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43A551-39C6-4F69-B9C2-D1EB4B4182AB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84838-852D-4DD5-BE68-2604436C78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4105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43A551-39C6-4F69-B9C2-D1EB4B4182AB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84838-852D-4DD5-BE68-2604436C78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6199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43A551-39C6-4F69-B9C2-D1EB4B4182AB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84838-852D-4DD5-BE68-2604436C78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9895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43A551-39C6-4F69-B9C2-D1EB4B4182AB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84838-852D-4DD5-BE68-2604436C78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9215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43A551-39C6-4F69-B9C2-D1EB4B4182AB}" type="datetimeFigureOut">
              <a:rPr kumimoji="1" lang="ja-JP" altLang="en-US" smtClean="0"/>
              <a:t>2014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B84838-852D-4DD5-BE68-2604436C78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1862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50526222"/>
              </p:ext>
            </p:extLst>
          </p:nvPr>
        </p:nvGraphicFramePr>
        <p:xfrm>
          <a:off x="70992" y="908720"/>
          <a:ext cx="9073008" cy="430023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32048"/>
                <a:gridCol w="85800"/>
                <a:gridCol w="1498376"/>
                <a:gridCol w="504056"/>
                <a:gridCol w="1296144"/>
                <a:gridCol w="1152128"/>
                <a:gridCol w="648072"/>
                <a:gridCol w="864096"/>
                <a:gridCol w="504056"/>
                <a:gridCol w="432048"/>
                <a:gridCol w="360040"/>
                <a:gridCol w="1296144"/>
              </a:tblGrid>
              <a:tr h="30028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  <a:latin typeface="+mn-lt"/>
                        </a:rPr>
                        <a:t> Patient 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  <a:latin typeface="+mn-lt"/>
                        </a:rPr>
                        <a:t>Initial diagnosis on 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  <a:latin typeface="+mn-lt"/>
                        </a:rPr>
                        <a:t>FIGO 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Final diagnosis on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Depth of 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Lymphovascular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  <a:latin typeface="+mn-lt"/>
                        </a:rPr>
                        <a:t>T 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  <a:latin typeface="+mn-lt"/>
                        </a:rPr>
                        <a:t>N 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M **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Recurrenc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1449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No.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900" b="1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  <a:p>
                      <a:pPr algn="ctr" fontAlgn="ctr"/>
                      <a:r>
                        <a:rPr lang="ja-JP" altLang="en-US" sz="900" b="1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 err="1">
                          <a:effectLst/>
                          <a:latin typeface="+mn-lt"/>
                        </a:rPr>
                        <a:t>colposcopic</a:t>
                      </a:r>
                      <a:r>
                        <a:rPr lang="en-US" sz="900" b="1" u="none" strike="noStrike" dirty="0">
                          <a:effectLst/>
                          <a:latin typeface="+mn-lt"/>
                        </a:rPr>
                        <a:t> selective biopsy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1" u="none" strike="noStrike" dirty="0" smtClean="0">
                          <a:effectLst/>
                          <a:latin typeface="+mn-lt"/>
                        </a:rPr>
                        <a:t>stage</a:t>
                      </a:r>
                      <a:endParaRPr lang="en-US" altLang="ja-JP" sz="900" b="1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  <a:p>
                      <a:pPr algn="ctr" fontAlgn="ctr"/>
                      <a:r>
                        <a:rPr lang="ja-JP" altLang="en-US" sz="900" b="1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1" u="none" strike="noStrike" dirty="0" smtClean="0">
                          <a:effectLst/>
                          <a:latin typeface="+mn-lt"/>
                        </a:rPr>
                        <a:t>Treatment(s) *)</a:t>
                      </a:r>
                      <a:endParaRPr lang="en-US" altLang="ja-JP" sz="900" b="1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  <a:p>
                      <a:pPr algn="ctr" fontAlgn="ctr"/>
                      <a:r>
                        <a:rPr lang="ja-JP" altLang="en-US" sz="900" b="1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surgical specimen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invasion (mm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space invasion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1" u="none" strike="noStrike" dirty="0" smtClean="0">
                          <a:effectLst/>
                          <a:latin typeface="+mn-lt"/>
                        </a:rPr>
                        <a:t>**)</a:t>
                      </a:r>
                      <a:endParaRPr lang="en-US" altLang="ja-JP" sz="900" b="1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  <a:p>
                      <a:pPr algn="ctr" fontAlgn="ctr"/>
                      <a:r>
                        <a:rPr lang="ja-JP" altLang="en-US" sz="900" b="1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900" b="1" u="none" strike="noStrike" dirty="0" smtClean="0">
                          <a:effectLst/>
                          <a:latin typeface="+mn-lt"/>
                        </a:rPr>
                        <a:t>**)</a:t>
                      </a:r>
                      <a:endParaRPr lang="en-US" altLang="ja-JP" sz="900" b="1" i="0" u="none" strike="noStrike" dirty="0" smtClean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  <a:p>
                      <a:pPr algn="ctr" fontAlgn="ctr"/>
                      <a:r>
                        <a:rPr lang="ja-JP" altLang="en-US" sz="900" b="1" u="none" strike="noStrike" dirty="0">
                          <a:effectLst/>
                          <a:latin typeface="+mn-lt"/>
                        </a:rPr>
                        <a:t>　</a:t>
                      </a:r>
                      <a:endParaRPr lang="ja-JP" alt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900" b="1" u="none" strike="noStrike">
                          <a:effectLst/>
                          <a:latin typeface="+mn-lt"/>
                        </a:rPr>
                        <a:t>***</a:t>
                      </a:r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)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and prognosis ****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1449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13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PSCC, invasion (-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  <a:latin typeface="+mn-lt"/>
                        </a:rPr>
                        <a:t>IA2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 err="1">
                          <a:effectLst/>
                          <a:latin typeface="+mn-lt"/>
                        </a:rPr>
                        <a:t>conization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SCC, microinvasiv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4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-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T1a2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-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17M no recurrenc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8512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14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PSCC, invasion (-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IB1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  <a:latin typeface="+mn-lt"/>
                        </a:rPr>
                        <a:t>RH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SCC, microinvasiv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1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-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T1b1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49M no recurrenc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1449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15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PSCC, invasion; ambiguous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IB1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RH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  <a:latin typeface="+mn-lt"/>
                        </a:rPr>
                        <a:t>SCC, non-keratinizing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3.5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+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T2a1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44M no recurrenc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1449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16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PSCC, invasion; ambiguous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IB1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RH + chemo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  <a:latin typeface="+mn-lt"/>
                        </a:rPr>
                        <a:t>SCC, non-keratinizing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5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+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T2b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1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32M no recurrenc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1449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17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PSCC, invasion; ambiguous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IB1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conization + TAH + radiation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  <a:latin typeface="+mn-lt"/>
                        </a:rPr>
                        <a:t>SCC, non-keratinizing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1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+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T1b1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-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26M no recurrenc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1449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18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PSCC, invasion; ambiguous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IB1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RH + radiation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adenosquamous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11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 dirty="0">
                          <a:effectLst/>
                          <a:latin typeface="+mn-lt"/>
                        </a:rPr>
                        <a:t>-</a:t>
                      </a:r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T1b1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120M no recurrenc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1449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19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PSCC, invasion (+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IB1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RH + chemo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SCC, non-keratinizing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 dirty="0">
                          <a:effectLst/>
                          <a:latin typeface="+mn-lt"/>
                        </a:rPr>
                        <a:t>14</a:t>
                      </a:r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 dirty="0">
                          <a:effectLst/>
                          <a:latin typeface="+mn-lt"/>
                        </a:rPr>
                        <a:t>+</a:t>
                      </a:r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T2b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1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32M no recurrenc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1449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2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PSCC, invasion; ambiguous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IB2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chemo + RH + chemo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SCC, non-keratinizing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7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 dirty="0">
                          <a:effectLst/>
                          <a:latin typeface="+mn-lt"/>
                        </a:rPr>
                        <a:t>-</a:t>
                      </a:r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yT1b1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y0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y0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38M no recurrenc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1449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21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PSCC, invasion (+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IB2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RH + radiation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SCC, non-keratinizing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1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+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T2b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1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7M recurrence, 32M death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1449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22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PSCC, invasion; ambiguous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IB2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RH + chemoradiotherapy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SCC, non-keratinizing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2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+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T2b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1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 dirty="0">
                          <a:effectLst/>
                          <a:latin typeface="+mn-lt"/>
                        </a:rPr>
                        <a:t>0</a:t>
                      </a:r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22M recurrence, 35M death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1449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23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PSCC, invasion (+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IIA1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chemo + RH + radiation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SCC, non-keratinizing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3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-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  <a:latin typeface="+mn-lt"/>
                        </a:rPr>
                        <a:t>yT1b1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y0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  <a:latin typeface="+mn-lt"/>
                        </a:rPr>
                        <a:t>y0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  <a:latin typeface="+mn-lt"/>
                        </a:rPr>
                        <a:t>115M no recurrenc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1449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24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PSCC, invasion; ambiguous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IIB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chemo + RH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SCC, non-keratinizing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-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yT2b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y1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y0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35M no recurrenc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1449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25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PSCC, invasion (+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IIB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chemo + RH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SCC, non-keratinizing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1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+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yT2b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  <a:latin typeface="+mn-lt"/>
                        </a:rPr>
                        <a:t>y1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yA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1M recurrence, 46M death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1449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26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PSCC, invasion (+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IIB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chemo + RH + chemo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SCC, non-keratinizing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10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+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yT2b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y1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y0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37M no recurrenc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21449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27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PSCC, invasion; ambiguous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IIB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chemo + RH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SCC, non-keratinizing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12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+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yT2b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y1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 err="1">
                          <a:effectLst/>
                          <a:latin typeface="+mn-lt"/>
                        </a:rPr>
                        <a:t>yA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12M recurrence, 40M aliv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  <a:tr h="30028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28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PSCC, invasion (+)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IIB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chemo + RH + radiation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SCC, non-keratinizing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15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1" u="none" strike="noStrike">
                          <a:effectLst/>
                          <a:latin typeface="+mn-lt"/>
                        </a:rPr>
                        <a:t>+</a:t>
                      </a:r>
                      <a:endParaRPr lang="en-US" altLang="ja-JP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yT2b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y1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+mn-lt"/>
                        </a:rPr>
                        <a:t>y0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  <a:latin typeface="+mn-lt"/>
                        </a:rPr>
                        <a:t>53M no recurrenc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895" marR="5895" marT="5895" marB="0" anchor="ctr">
                    <a:solidFill>
                      <a:schemeClr val="tx2">
                        <a:lumMod val="40000"/>
                        <a:lumOff val="60000"/>
                      </a:schemeClr>
                    </a:solidFill>
                  </a:tcPr>
                </a:tc>
              </a:tr>
            </a:tbl>
          </a:graphicData>
        </a:graphic>
      </p:graphicFrame>
      <p:cxnSp>
        <p:nvCxnSpPr>
          <p:cNvPr id="4" name="直線コネクタ 3"/>
          <p:cNvCxnSpPr/>
          <p:nvPr/>
        </p:nvCxnSpPr>
        <p:spPr>
          <a:xfrm>
            <a:off x="0" y="1464325"/>
            <a:ext cx="9144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テキスト ボックス 4"/>
          <p:cNvSpPr txBox="1"/>
          <p:nvPr/>
        </p:nvSpPr>
        <p:spPr>
          <a:xfrm>
            <a:off x="75686" y="5378946"/>
            <a:ext cx="5866671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smtClean="0"/>
              <a:t>Table </a:t>
            </a:r>
            <a:r>
              <a:rPr kumimoji="1" lang="en-US" altLang="ja-JP" sz="1200" b="1" smtClean="0"/>
              <a:t>S2</a:t>
            </a:r>
            <a:r>
              <a:rPr lang="en-US" altLang="ja-JP" sz="1200" b="1" dirty="0"/>
              <a:t>.</a:t>
            </a:r>
            <a:r>
              <a:rPr lang="en-US" altLang="ja-JP" sz="1200" dirty="0"/>
              <a:t> The </a:t>
            </a:r>
            <a:r>
              <a:rPr lang="en-US" altLang="ja-JP" sz="1200" dirty="0" err="1"/>
              <a:t>clinicopathological</a:t>
            </a:r>
            <a:r>
              <a:rPr lang="en-US" altLang="ja-JP" sz="1200" dirty="0"/>
              <a:t> data of the 16 false PSCC </a:t>
            </a:r>
            <a:r>
              <a:rPr lang="en-US" altLang="ja-JP" sz="1200" dirty="0" smtClean="0"/>
              <a:t>patients.</a:t>
            </a:r>
          </a:p>
          <a:p>
            <a:r>
              <a:rPr lang="en-US" altLang="ja-JP" sz="1200" dirty="0" smtClean="0"/>
              <a:t>*) RH = radical hysterectomy, chemo = chemotherapy, TAH = total abdominal hysterectomy.</a:t>
            </a:r>
          </a:p>
          <a:p>
            <a:r>
              <a:rPr lang="en-US" altLang="ja-JP" sz="1200" dirty="0" smtClean="0"/>
              <a:t>**) "y" indicates a performance of preoperative treatment.</a:t>
            </a:r>
          </a:p>
          <a:p>
            <a:r>
              <a:rPr lang="en-US" altLang="ja-JP" sz="1200" dirty="0" smtClean="0"/>
              <a:t>***) A = </a:t>
            </a:r>
            <a:r>
              <a:rPr lang="en-US" altLang="ja-JP" sz="1200" dirty="0" err="1" smtClean="0"/>
              <a:t>paraaortic</a:t>
            </a:r>
            <a:r>
              <a:rPr lang="en-US" altLang="ja-JP" sz="1200" dirty="0" smtClean="0"/>
              <a:t> lymph node metastasis. </a:t>
            </a:r>
          </a:p>
          <a:p>
            <a:r>
              <a:rPr lang="en-US" altLang="ja-JP" sz="1200" dirty="0"/>
              <a:t>****) M = month(s</a:t>
            </a:r>
            <a:r>
              <a:rPr lang="en-US" altLang="ja-JP" sz="1200" dirty="0" smtClean="0"/>
              <a:t>).</a:t>
            </a:r>
            <a:endParaRPr kumimoji="1"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4183681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434</Words>
  <Application>Microsoft Office PowerPoint</Application>
  <PresentationFormat>画面に合わせる (4:3)</PresentationFormat>
  <Paragraphs>208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越山雅文</dc:creator>
  <cp:lastModifiedBy>越山雅文</cp:lastModifiedBy>
  <cp:revision>6</cp:revision>
  <dcterms:created xsi:type="dcterms:W3CDTF">2014-09-20T10:02:19Z</dcterms:created>
  <dcterms:modified xsi:type="dcterms:W3CDTF">2014-11-05T00:15:46Z</dcterms:modified>
</cp:coreProperties>
</file>